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0" r:id="rId2"/>
  </p:sldIdLst>
  <p:sldSz cx="6858000" cy="9906000" type="A4"/>
  <p:notesSz cx="6858000" cy="9144000"/>
  <p:defaultTextStyle>
    <a:defPPr>
      <a:defRPr lang="zh-CN"/>
    </a:defPPr>
    <a:lvl1pPr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2BB5F0"/>
    <a:srgbClr val="0054FF"/>
    <a:srgbClr val="3C69C4"/>
    <a:srgbClr val="F20217"/>
    <a:srgbClr val="4CACE1"/>
    <a:srgbClr val="EF3F65"/>
    <a:srgbClr val="25F33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18" autoAdjust="0"/>
    <p:restoredTop sz="94629"/>
  </p:normalViewPr>
  <p:slideViewPr>
    <p:cSldViewPr snapToGrid="0" snapToObjects="1">
      <p:cViewPr varScale="1">
        <p:scale>
          <a:sx n="47" d="100"/>
          <a:sy n="47" d="100"/>
        </p:scale>
        <p:origin x="2240" y="5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B9978661-16FA-4649-AC76-FDE7A06178F6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7BA467A0-0B42-43BF-9FDE-CC736A40EE2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5980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8BDDC50B-1665-44B0-8541-4C1723F133FC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B609A6DE-25F2-4224-90BA-F640DE6D239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370143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321D5E-2E4E-4D09-B17F-AAA65AB1F8B3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F5E028-4AAA-42CB-9920-FA37FED2B9A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0784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8AA147-65D1-43B7-A09C-C7F6AC787A20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295EF-536C-4304-A018-E63893449F1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0390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A9664B-E041-4D5F-83E1-161C93359AFD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D3D22A-E256-4341-9D36-8F3F3F4C381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2098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DFDD67-3CFE-4CD6-BEA3-B41E0CC57996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0E46F2-F4A8-42C5-90EF-2C06260A014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548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ADE566-E6B1-4EFF-9E9E-B0457A79BE1B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35E792-6F12-4290-A40C-54F4E93325B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3184BA-B1ED-4145-B07E-C06870A8C964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71D00C-8E4E-4EA7-A0A2-0181DE0C4CE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707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6CAA5E-4C72-4401-A32A-3B8BE0C1ED7A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14F16-6D0C-4F85-A177-486EB85D5C4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0295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374F58-31E6-48D4-B390-393E1CF9591D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F5E39A-B3BA-4CDD-BEFD-2694A1E606A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7693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E5AE50-54C4-4A89-9452-42CA6F53D2BA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90412C-59A9-4557-8A39-52A51DCB703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4512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1F1BCF-95BB-4B07-AEC4-D936090AC7B8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865AE3-B9CB-46B4-ACBD-C12E662030A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5112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243FDB-2F41-4AAE-8890-E32CBCAC3353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AC2318-177F-49CB-9922-4CB4292E13E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3719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 smtClean="0">
                <a:solidFill>
                  <a:srgbClr val="898989"/>
                </a:solidFill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149208FF-5AC3-45C4-A226-79FF54700252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solidFill>
                  <a:srgbClr val="898989"/>
                </a:solidFill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3C7DF0E7-5CD2-486A-9069-B217B4E6612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宋体" charset="0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宋体" charset="0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25">
            <a:extLst>
              <a:ext uri="{FF2B5EF4-FFF2-40B4-BE49-F238E27FC236}">
                <a16:creationId xmlns:a16="http://schemas.microsoft.com/office/drawing/2014/main" id="{88961E03-782A-C84F-9CBC-D403709D7D69}"/>
              </a:ext>
            </a:extLst>
          </p:cNvPr>
          <p:cNvSpPr txBox="1"/>
          <p:nvPr/>
        </p:nvSpPr>
        <p:spPr>
          <a:xfrm>
            <a:off x="629287" y="6578667"/>
            <a:ext cx="5794991" cy="1577781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endParaRPr lang="zh-CN" sz="120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5" name="组合 24"/>
          <p:cNvGrpSpPr/>
          <p:nvPr/>
        </p:nvGrpSpPr>
        <p:grpSpPr>
          <a:xfrm>
            <a:off x="175050" y="696865"/>
            <a:ext cx="6262325" cy="3197075"/>
            <a:chOff x="175050" y="696865"/>
            <a:chExt cx="6262325" cy="3197075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982F1DA1-C7A6-C144-9800-CE445F4CAD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0" b="49419"/>
            <a:stretch/>
          </p:blipFill>
          <p:spPr>
            <a:xfrm>
              <a:off x="695324" y="696865"/>
              <a:ext cx="5742051" cy="2941685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904875" y="885825"/>
              <a:ext cx="7239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534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453080" y="1205389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453080" y="1605719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453080" y="2021285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453080" y="2459715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53080" y="2857210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453080" y="3297159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2386378" y="3616941"/>
              <a:ext cx="23855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caled GC-corrected read coun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6200000">
              <a:off x="-801499" y="2151333"/>
              <a:ext cx="22300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roportion of supporting reads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组合 23"/>
          <p:cNvGrpSpPr/>
          <p:nvPr/>
        </p:nvGrpSpPr>
        <p:grpSpPr>
          <a:xfrm>
            <a:off x="175050" y="3914470"/>
            <a:ext cx="6294314" cy="3179740"/>
            <a:chOff x="143061" y="4169860"/>
            <a:chExt cx="6294314" cy="3179740"/>
          </a:xfrm>
        </p:grpSpPr>
        <p:sp>
          <p:nvSpPr>
            <p:cNvPr id="13" name="文本框 12"/>
            <p:cNvSpPr txBox="1"/>
            <p:nvPr/>
          </p:nvSpPr>
          <p:spPr>
            <a:xfrm>
              <a:off x="453080" y="4550355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453080" y="4950685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453080" y="5366251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453080" y="5804681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453080" y="6202176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453080" y="6642125"/>
              <a:ext cx="3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982F1DA1-C7A6-C144-9800-CE445F4CAD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0" t="51727"/>
            <a:stretch/>
          </p:blipFill>
          <p:spPr>
            <a:xfrm>
              <a:off x="695324" y="4286751"/>
              <a:ext cx="5742051" cy="2807459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872827" y="4169860"/>
              <a:ext cx="7239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650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6200000">
              <a:off x="-833488" y="5551981"/>
              <a:ext cx="22300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roportion of supporting reads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>
              <a:off x="2386378" y="7072601"/>
              <a:ext cx="23855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caled GC-corrected read coun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73009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448</TotalTime>
  <Words>30</Words>
  <Application>Microsoft Office PowerPoint</Application>
  <PresentationFormat>A4 纸张(210x297 毫米)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DengXian</vt:lpstr>
      <vt:lpstr>DengXian</vt:lpstr>
      <vt:lpstr>宋体</vt:lpstr>
      <vt:lpstr>Arial</vt:lpstr>
      <vt:lpstr>Calibri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tt</dc:creator>
  <cp:lastModifiedBy>GPB</cp:lastModifiedBy>
  <cp:revision>337</cp:revision>
  <cp:lastPrinted>2018-12-18T01:41:20Z</cp:lastPrinted>
  <dcterms:created xsi:type="dcterms:W3CDTF">2017-02-19T15:35:43Z</dcterms:created>
  <dcterms:modified xsi:type="dcterms:W3CDTF">2021-05-30T13:49:33Z</dcterms:modified>
</cp:coreProperties>
</file>